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67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2A8E22-8EE8-4D69-9A40-C0AA7851B50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CAEBBC8-F205-45BE-90B7-C1282960783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3058D8D-F100-46A8-A517-95EA6601E5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652CC-038F-487E-84A7-608F99D2D56E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99BC01F-17A7-424E-A945-960480D89F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E970A85-2F93-4C6A-B8E5-F8F0CD6287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DAF68C-16AA-4B2E-98AD-DC5639E61B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67192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FEC30E-CFCD-4289-87FB-814F585DEC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442C824-9782-4B39-8D5C-14EEEA9C68B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78BE111-EE91-4A64-BB1B-84B0E4A562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652CC-038F-487E-84A7-608F99D2D56E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B8839B-032F-404D-A4D2-817733AD54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E86C98-9FDA-4C94-9B15-A2FFA13D0E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DAF68C-16AA-4B2E-98AD-DC5639E61B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84479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FCC4166-0FFE-4C5B-B3D1-5452F800F67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B757908-BA1E-4276-9131-8B3E1099AF3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3EC4C3-B86E-44B7-AAA9-458409EBE5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652CC-038F-487E-84A7-608F99D2D56E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4E18F5-CC22-457D-99F0-8C8AF0E2E5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94B9E43-7FC3-4E1C-ABF2-BC56017F10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DAF68C-16AA-4B2E-98AD-DC5639E61B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28143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FB0BE0-195A-4FB0-8E70-9A48DC89C0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632DDB8-35C9-42B5-B23D-A9BF24D4AF3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1D99A4-0A8D-4C53-85B2-7D4C38E08E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652CC-038F-487E-84A7-608F99D2D56E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8E7BAE-3634-4D78-B547-AB117519AD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D97153-FBE3-4E41-AC42-7D1E3E0B77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DAF68C-16AA-4B2E-98AD-DC5639E61B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23527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BEDE6F-14F5-4370-9F99-999597A258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62B2D61-C600-4A7A-A82A-9414B0DEA0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02A2FB-89A7-48D1-8088-7E3AF90339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652CC-038F-487E-84A7-608F99D2D56E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2407269-7AB9-46D6-B49A-B061083BA3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F44A77-65D0-4D92-A88E-985A07E3DA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DAF68C-16AA-4B2E-98AD-DC5639E61B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32469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49746F-0A74-4101-AEB6-9DCDA2E178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B85DAF1-3352-4D0B-8824-83F8E5DBA1F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96AFD2F-3E72-40A5-986C-CD0F349AF48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6227BF8-69AD-467F-9609-BC622A7765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652CC-038F-487E-84A7-608F99D2D56E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3C4C023-8E42-4DFB-BC74-43911986C5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7A14F50-11B0-45EE-8703-555C65B325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DAF68C-16AA-4B2E-98AD-DC5639E61B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2462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5A57D5-BBDB-4E41-A17D-ABC9514C42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49D6D71-92C8-4ED1-ACE7-05A3C7C956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E68C382-4C3B-48DC-88CF-155C1553893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58224C7-6909-4EC3-85D1-6E75EC9AAE5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02CB5B4-08EC-43CB-94EE-935419037DF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A50A69B-8FFC-43AC-A898-65EAD6EEBF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652CC-038F-487E-84A7-608F99D2D56E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FD73D40-B4FB-4D01-83BF-3390C766CB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F184EF3-CD39-446D-A1AD-839850F682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DAF68C-16AA-4B2E-98AD-DC5639E61B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00746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01DA02-C7FE-4E25-88B8-B4E8EA49FD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E725E31-5828-4F69-9CF2-2490C508E0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652CC-038F-487E-84A7-608F99D2D56E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728712D-4C1D-487A-80D3-C5803475FA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F8131B3-0485-4C66-9C6F-B2223F0327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DAF68C-16AA-4B2E-98AD-DC5639E61B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85334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0120706-BDF7-46E6-859A-BFD9DD6CB9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652CC-038F-487E-84A7-608F99D2D56E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4E97543-CF87-4E1F-A518-D43C4B0997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DBAF17E-4A11-4A70-936F-337B2AFD4C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DAF68C-16AA-4B2E-98AD-DC5639E61B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48924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9D0ADD-A521-4A7F-8FA4-74032CDA36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C0A5754-4808-4183-95EF-EBE0BEF8F16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5C68DEC-637E-44FA-818C-54B12B3DDFE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4440944-46C8-4517-88BC-9A2AB287E6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652CC-038F-487E-84A7-608F99D2D56E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0DA6B9F-4BF0-47B2-9F07-0922477170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1D25B69-F638-4657-B30C-AF51673A08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DAF68C-16AA-4B2E-98AD-DC5639E61B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38150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BACBA6-B322-45A5-BBFF-F378C2A77F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D8488F4-4BE0-408B-B77E-E4524ADD625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9FC7A35-3284-4B17-A863-D603FF17EDF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C6C7EE3-80E2-4F3C-BEA7-FF1D7B9C1B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652CC-038F-487E-84A7-608F99D2D56E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7E68C1B-9789-4CC3-931F-1357812E30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AA6DF23-8334-4B27-87FA-F8E43B8B61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DAF68C-16AA-4B2E-98AD-DC5639E61B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20318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E5F0F85-51EB-4F57-8F11-C9078A940B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A3A5E6B-807A-4066-A8B7-DE86949230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83CD5F2-C064-4C4B-B7E5-CE892C91EC7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7652CC-038F-487E-84A7-608F99D2D56E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3181D7-D5AB-409C-AF7B-9ED7748C0F6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386F6F-4326-4B2C-A7D1-F90F517866A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DAF68C-16AA-4B2E-98AD-DC5639E61B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03260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36FE0305-2EFF-46C1-A839-F89A081AC18B}"/>
              </a:ext>
            </a:extLst>
          </p:cNvPr>
          <p:cNvGrpSpPr/>
          <p:nvPr/>
        </p:nvGrpSpPr>
        <p:grpSpPr>
          <a:xfrm>
            <a:off x="2713247" y="904680"/>
            <a:ext cx="6202018" cy="5048639"/>
            <a:chOff x="866692" y="819010"/>
            <a:chExt cx="6202018" cy="5048639"/>
          </a:xfrm>
        </p:grpSpPr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1BB08245-3DCE-4100-841C-C59F0EB5A445}"/>
                </a:ext>
              </a:extLst>
            </p:cNvPr>
            <p:cNvGrpSpPr/>
            <p:nvPr/>
          </p:nvGrpSpPr>
          <p:grpSpPr>
            <a:xfrm>
              <a:off x="866693" y="819010"/>
              <a:ext cx="6202017" cy="4425361"/>
              <a:chOff x="1169578" y="461142"/>
              <a:chExt cx="7909550" cy="5446045"/>
            </a:xfrm>
          </p:grpSpPr>
          <p:pic>
            <p:nvPicPr>
              <p:cNvPr id="16" name="Picture 15">
                <a:extLst>
                  <a:ext uri="{FF2B5EF4-FFF2-40B4-BE49-F238E27FC236}">
                    <a16:creationId xmlns:a16="http://schemas.microsoft.com/office/drawing/2014/main" id="{7134BCA1-14AA-4901-8F7A-11B25BC7787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contrast="2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4885257" y="849413"/>
                <a:ext cx="4193871" cy="5057774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8" name="Picture 17">
                <a:extLst>
                  <a:ext uri="{FF2B5EF4-FFF2-40B4-BE49-F238E27FC236}">
                    <a16:creationId xmlns:a16="http://schemas.microsoft.com/office/drawing/2014/main" id="{76C98214-E7DC-4206-882B-A1E6B4DCA4D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40000" contrast="-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9212" t="12727" r="4154" b="13199"/>
              <a:stretch/>
            </p:blipFill>
            <p:spPr>
              <a:xfrm rot="10800000">
                <a:off x="1169578" y="849413"/>
                <a:ext cx="3611423" cy="5057774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cxnSp>
            <p:nvCxnSpPr>
              <p:cNvPr id="7" name="Straight Connector 6">
                <a:extLst>
                  <a:ext uri="{FF2B5EF4-FFF2-40B4-BE49-F238E27FC236}">
                    <a16:creationId xmlns:a16="http://schemas.microsoft.com/office/drawing/2014/main" id="{5C1486EE-D7FC-4D5C-B90F-27553D3262CD}"/>
                  </a:ext>
                </a:extLst>
              </p:cNvPr>
              <p:cNvCxnSpPr/>
              <p:nvPr/>
            </p:nvCxnSpPr>
            <p:spPr>
              <a:xfrm>
                <a:off x="3991555" y="5716987"/>
                <a:ext cx="485029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" name="Straight Connector 11">
                <a:extLst>
                  <a:ext uri="{FF2B5EF4-FFF2-40B4-BE49-F238E27FC236}">
                    <a16:creationId xmlns:a16="http://schemas.microsoft.com/office/drawing/2014/main" id="{2A598FE8-875F-43A8-99BC-3F5F5230D2F2}"/>
                  </a:ext>
                </a:extLst>
              </p:cNvPr>
              <p:cNvCxnSpPr/>
              <p:nvPr/>
            </p:nvCxnSpPr>
            <p:spPr>
              <a:xfrm>
                <a:off x="8421757" y="5702409"/>
                <a:ext cx="485029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6E38E492-6E52-4760-8D4E-026E96F481B3}"/>
                  </a:ext>
                </a:extLst>
              </p:cNvPr>
              <p:cNvSpPr txBox="1"/>
              <p:nvPr/>
            </p:nvSpPr>
            <p:spPr>
              <a:xfrm>
                <a:off x="8311032" y="5371494"/>
                <a:ext cx="726150" cy="34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 mm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CD03D2D9-910C-453A-B9C7-BED83650FD0B}"/>
                  </a:ext>
                </a:extLst>
              </p:cNvPr>
              <p:cNvSpPr txBox="1"/>
              <p:nvPr/>
            </p:nvSpPr>
            <p:spPr>
              <a:xfrm>
                <a:off x="3903360" y="5381279"/>
                <a:ext cx="726150" cy="34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 mm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11357432-E4DA-40DC-B3AA-A89BEAB17B69}"/>
                  </a:ext>
                </a:extLst>
              </p:cNvPr>
              <p:cNvSpPr txBox="1"/>
              <p:nvPr/>
            </p:nvSpPr>
            <p:spPr>
              <a:xfrm>
                <a:off x="2343382" y="461142"/>
                <a:ext cx="1263812" cy="3787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/>
                  <a:t>Male sham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644ECF8E-5989-48A7-B714-E2DD5DD5547D}"/>
                  </a:ext>
                </a:extLst>
              </p:cNvPr>
              <p:cNvSpPr txBox="1"/>
              <p:nvPr/>
            </p:nvSpPr>
            <p:spPr>
              <a:xfrm>
                <a:off x="6303266" y="461143"/>
                <a:ext cx="1357851" cy="3787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/>
                  <a:t>Male </a:t>
                </a:r>
                <a:r>
                  <a:rPr lang="en-US" sz="1400" dirty="0" err="1"/>
                  <a:t>mbTBI</a:t>
                </a:r>
                <a:endParaRPr lang="en-US" sz="1400" dirty="0"/>
              </a:p>
            </p:txBody>
          </p:sp>
        </p:grpSp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FD5E04F0-F2EF-47FB-AC8C-5B5D2309CD42}"/>
                </a:ext>
              </a:extLst>
            </p:cNvPr>
            <p:cNvSpPr/>
            <p:nvPr/>
          </p:nvSpPr>
          <p:spPr>
            <a:xfrm>
              <a:off x="866692" y="5405984"/>
              <a:ext cx="6202018" cy="46166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Representative brain sections from male sham and 3d post-</a:t>
              </a:r>
              <a:r>
                <a:rPr lang="en-US" sz="1200" dirty="0" err="1">
                  <a:latin typeface="Times New Roman" panose="02020603050405020304" pitchFamily="18" charset="0"/>
                  <a:ea typeface="Calibri" panose="020F0502020204030204" pitchFamily="34" charset="0"/>
                </a:rPr>
                <a:t>mbTBI</a:t>
              </a:r>
              <a:r>
                <a:rPr lang="en-US" sz="12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 stained with crystal violet. No apparent histological changes are observed between sham and mbTBI brain sections. </a:t>
              </a:r>
              <a:endParaRPr lang="en-US" sz="1200" dirty="0"/>
            </a:p>
          </p:txBody>
        </p:sp>
      </p:grpSp>
      <p:sp>
        <p:nvSpPr>
          <p:cNvPr id="3" name="Rectangle 2">
            <a:extLst>
              <a:ext uri="{FF2B5EF4-FFF2-40B4-BE49-F238E27FC236}">
                <a16:creationId xmlns:a16="http://schemas.microsoft.com/office/drawing/2014/main" id="{BFC80728-CAE3-4BB8-9922-0A1D5A87B2BE}"/>
              </a:ext>
            </a:extLst>
          </p:cNvPr>
          <p:cNvSpPr/>
          <p:nvPr/>
        </p:nvSpPr>
        <p:spPr>
          <a:xfrm>
            <a:off x="307379" y="130346"/>
            <a:ext cx="217880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 5.</a:t>
            </a:r>
          </a:p>
        </p:txBody>
      </p:sp>
    </p:spTree>
    <p:extLst>
      <p:ext uri="{BB962C8B-B14F-4D97-AF65-F5344CB8AC3E}">
        <p14:creationId xmlns:p14="http://schemas.microsoft.com/office/powerpoint/2010/main" val="21978088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5</TotalTime>
  <Words>39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llivan Lab</dc:creator>
  <cp:lastModifiedBy>Hubbard, Brad</cp:lastModifiedBy>
  <cp:revision>15</cp:revision>
  <dcterms:created xsi:type="dcterms:W3CDTF">2022-06-10T14:51:02Z</dcterms:created>
  <dcterms:modified xsi:type="dcterms:W3CDTF">2022-06-10T19:17:43Z</dcterms:modified>
</cp:coreProperties>
</file>